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58" r:id="rId2"/>
    <p:sldId id="259" r:id="rId3"/>
    <p:sldId id="261" r:id="rId4"/>
    <p:sldId id="262" r:id="rId5"/>
    <p:sldId id="263" r:id="rId6"/>
    <p:sldId id="264" r:id="rId7"/>
    <p:sldId id="265" r:id="rId8"/>
    <p:sldId id="266" r:id="rId9"/>
    <p:sldId id="267" r:id="rId10"/>
    <p:sldId id="275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60" r:id="rId1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67" autoAdjust="0"/>
    <p:restoredTop sz="94660"/>
  </p:normalViewPr>
  <p:slideViewPr>
    <p:cSldViewPr snapToGrid="0">
      <p:cViewPr varScale="1">
        <p:scale>
          <a:sx n="61" d="100"/>
          <a:sy n="61" d="100"/>
        </p:scale>
        <p:origin x="10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126E45-C35B-469D-AC81-FCA6CF85195F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1A5B9C-8381-4919-B9E7-E764B9BB25C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77070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1A5B9C-8381-4919-B9E7-E764B9BB25C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86348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637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054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3208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6668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8403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633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1193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3427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9816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5672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3273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09E8B-2EFB-4DFA-BE82-BB1CDFC7BD1A}" type="datetimeFigureOut">
              <a:rPr lang="zh-CN" altLang="en-US" smtClean="0"/>
              <a:t>2016/4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278199-7573-4A89-96E5-96768826CD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7622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5532437"/>
            <a:ext cx="10859814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A.1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1.</a:t>
            </a:r>
            <a:endParaRPr lang="zh-CN" altLang="en-US" sz="2400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7943" y="1181099"/>
            <a:ext cx="8660327" cy="4351338"/>
          </a:xfrm>
        </p:spPr>
      </p:pic>
    </p:spTree>
    <p:extLst>
      <p:ext uri="{BB962C8B-B14F-4D97-AF65-F5344CB8AC3E}">
        <p14:creationId xmlns:p14="http://schemas.microsoft.com/office/powerpoint/2010/main" val="307949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40979" y="5532437"/>
            <a:ext cx="11130455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10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1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6757" y="1181099"/>
            <a:ext cx="8798897" cy="4351338"/>
          </a:xfrm>
        </p:spPr>
      </p:pic>
    </p:spTree>
    <p:extLst>
      <p:ext uri="{BB962C8B-B14F-4D97-AF65-F5344CB8AC3E}">
        <p14:creationId xmlns:p14="http://schemas.microsoft.com/office/powerpoint/2010/main" val="2002280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56745" y="5532437"/>
            <a:ext cx="11020096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11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2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8127" y="1181099"/>
            <a:ext cx="8777331" cy="4351338"/>
          </a:xfrm>
        </p:spPr>
      </p:pic>
    </p:spTree>
    <p:extLst>
      <p:ext uri="{BB962C8B-B14F-4D97-AF65-F5344CB8AC3E}">
        <p14:creationId xmlns:p14="http://schemas.microsoft.com/office/powerpoint/2010/main" val="15716818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56745" y="5532437"/>
            <a:ext cx="11083158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12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3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7150" y="1181099"/>
            <a:ext cx="8842348" cy="4351338"/>
          </a:xfrm>
        </p:spPr>
      </p:pic>
    </p:spTree>
    <p:extLst>
      <p:ext uri="{BB962C8B-B14F-4D97-AF65-F5344CB8AC3E}">
        <p14:creationId xmlns:p14="http://schemas.microsoft.com/office/powerpoint/2010/main" val="3145877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93683" y="5532437"/>
            <a:ext cx="11051627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13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4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4636" y="1181099"/>
            <a:ext cx="8809719" cy="4351338"/>
          </a:xfrm>
        </p:spPr>
      </p:pic>
    </p:spTree>
    <p:extLst>
      <p:ext uri="{BB962C8B-B14F-4D97-AF65-F5344CB8AC3E}">
        <p14:creationId xmlns:p14="http://schemas.microsoft.com/office/powerpoint/2010/main" val="19352661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56745" y="5532437"/>
            <a:ext cx="11146221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14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5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4507" y="1181099"/>
            <a:ext cx="8890696" cy="4351338"/>
          </a:xfrm>
        </p:spPr>
      </p:pic>
    </p:spTree>
    <p:extLst>
      <p:ext uri="{BB962C8B-B14F-4D97-AF65-F5344CB8AC3E}">
        <p14:creationId xmlns:p14="http://schemas.microsoft.com/office/powerpoint/2010/main" val="24413932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5213" y="5532437"/>
            <a:ext cx="11209283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15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6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6560" y="1181099"/>
            <a:ext cx="8766587" cy="4351338"/>
          </a:xfrm>
        </p:spPr>
      </p:pic>
    </p:spTree>
    <p:extLst>
      <p:ext uri="{BB962C8B-B14F-4D97-AF65-F5344CB8AC3E}">
        <p14:creationId xmlns:p14="http://schemas.microsoft.com/office/powerpoint/2010/main" val="20262323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93683" y="5532437"/>
            <a:ext cx="11114689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16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7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1578" y="1181099"/>
            <a:ext cx="8798897" cy="4351338"/>
          </a:xfrm>
        </p:spPr>
      </p:pic>
    </p:spTree>
    <p:extLst>
      <p:ext uri="{BB962C8B-B14F-4D97-AF65-F5344CB8AC3E}">
        <p14:creationId xmlns:p14="http://schemas.microsoft.com/office/powerpoint/2010/main" val="3476881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56745" y="5532437"/>
            <a:ext cx="11209283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17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8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0212" y="1181099"/>
            <a:ext cx="8842348" cy="4351338"/>
          </a:xfrm>
        </p:spPr>
      </p:pic>
    </p:spTree>
    <p:extLst>
      <p:ext uri="{BB962C8B-B14F-4D97-AF65-F5344CB8AC3E}">
        <p14:creationId xmlns:p14="http://schemas.microsoft.com/office/powerpoint/2010/main" val="2201204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5213" y="5532437"/>
            <a:ext cx="11161987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18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9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2912" y="1181099"/>
            <a:ext cx="8766587" cy="4351338"/>
          </a:xfrm>
        </p:spPr>
      </p:pic>
    </p:spTree>
    <p:extLst>
      <p:ext uri="{BB962C8B-B14F-4D97-AF65-F5344CB8AC3E}">
        <p14:creationId xmlns:p14="http://schemas.microsoft.com/office/powerpoint/2010/main" val="13537428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199" y="5532437"/>
            <a:ext cx="10938641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2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2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9421" y="1181099"/>
            <a:ext cx="8756196" cy="4351338"/>
          </a:xfrm>
        </p:spPr>
      </p:pic>
    </p:spTree>
    <p:extLst>
      <p:ext uri="{BB962C8B-B14F-4D97-AF65-F5344CB8AC3E}">
        <p14:creationId xmlns:p14="http://schemas.microsoft.com/office/powerpoint/2010/main" val="16318630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199" y="5532437"/>
            <a:ext cx="10891345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3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3.</a:t>
            </a:r>
            <a:endParaRPr lang="zh-CN" altLang="en-US" sz="2400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2270" y="1181099"/>
            <a:ext cx="8943201" cy="4351338"/>
          </a:xfrm>
        </p:spPr>
      </p:pic>
    </p:spTree>
    <p:extLst>
      <p:ext uri="{BB962C8B-B14F-4D97-AF65-F5344CB8AC3E}">
        <p14:creationId xmlns:p14="http://schemas.microsoft.com/office/powerpoint/2010/main" val="2683600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5532437"/>
            <a:ext cx="10985938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4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4.</a:t>
            </a:r>
            <a:endParaRPr lang="zh-CN" altLang="en-US" sz="2400" dirty="0"/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8449" y="1181099"/>
            <a:ext cx="8745440" cy="4351338"/>
          </a:xfrm>
        </p:spPr>
      </p:pic>
    </p:spTree>
    <p:extLst>
      <p:ext uri="{BB962C8B-B14F-4D97-AF65-F5344CB8AC3E}">
        <p14:creationId xmlns:p14="http://schemas.microsoft.com/office/powerpoint/2010/main" val="15945583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199" y="5532437"/>
            <a:ext cx="10954407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5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5.</a:t>
            </a:r>
            <a:endParaRPr lang="zh-CN" altLang="en-US" sz="2400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1088" y="1181099"/>
            <a:ext cx="8788627" cy="4351338"/>
          </a:xfrm>
        </p:spPr>
      </p:pic>
    </p:spTree>
    <p:extLst>
      <p:ext uri="{BB962C8B-B14F-4D97-AF65-F5344CB8AC3E}">
        <p14:creationId xmlns:p14="http://schemas.microsoft.com/office/powerpoint/2010/main" val="1539256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199" y="5532437"/>
            <a:ext cx="11017469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6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6.</a:t>
            </a:r>
            <a:endParaRPr lang="zh-CN" altLang="en-US" sz="2400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2619" y="1181099"/>
            <a:ext cx="8788627" cy="4351338"/>
          </a:xfrm>
        </p:spPr>
      </p:pic>
    </p:spTree>
    <p:extLst>
      <p:ext uri="{BB962C8B-B14F-4D97-AF65-F5344CB8AC3E}">
        <p14:creationId xmlns:p14="http://schemas.microsoft.com/office/powerpoint/2010/main" val="1092694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199" y="5532437"/>
            <a:ext cx="10938641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7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7.</a:t>
            </a:r>
            <a:endParaRPr lang="zh-CN" altLang="en-US" sz="2400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181" y="1181099"/>
            <a:ext cx="8702676" cy="4351338"/>
          </a:xfrm>
        </p:spPr>
      </p:pic>
    </p:spTree>
    <p:extLst>
      <p:ext uri="{BB962C8B-B14F-4D97-AF65-F5344CB8AC3E}">
        <p14:creationId xmlns:p14="http://schemas.microsoft.com/office/powerpoint/2010/main" val="5469770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199" y="5532437"/>
            <a:ext cx="10938641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8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8.</a:t>
            </a:r>
            <a:endParaRPr lang="zh-CN" altLang="en-US" sz="2400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181" y="1181099"/>
            <a:ext cx="8702676" cy="4351338"/>
          </a:xfrm>
        </p:spPr>
      </p:pic>
    </p:spTree>
    <p:extLst>
      <p:ext uri="{BB962C8B-B14F-4D97-AF65-F5344CB8AC3E}">
        <p14:creationId xmlns:p14="http://schemas.microsoft.com/office/powerpoint/2010/main" val="2100703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5532437"/>
            <a:ext cx="11033234" cy="1325563"/>
          </a:xfrm>
        </p:spPr>
        <p:txBody>
          <a:bodyPr>
            <a:norm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 </a:t>
            </a:r>
            <a:r>
              <a:rPr lang="en-US" altLang="zh-CN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9 </a:t>
            </a:r>
            <a:r>
              <a:rPr lang="en-US" altLang="zh-CN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BPC chromatograms of various micro-dissected tissues from Sample 9.</a:t>
            </a:r>
            <a:endParaRPr lang="zh-CN" altLang="en-US" sz="2400" dirty="0"/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7462" y="1181099"/>
            <a:ext cx="8734709" cy="4351338"/>
          </a:xfrm>
        </p:spPr>
      </p:pic>
    </p:spTree>
    <p:extLst>
      <p:ext uri="{BB962C8B-B14F-4D97-AF65-F5344CB8AC3E}">
        <p14:creationId xmlns:p14="http://schemas.microsoft.com/office/powerpoint/2010/main" val="24024861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235</Words>
  <Application>Microsoft Office PowerPoint</Application>
  <PresentationFormat>宽屏</PresentationFormat>
  <Paragraphs>19</Paragraphs>
  <Slides>1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8</vt:i4>
      </vt:variant>
    </vt:vector>
  </HeadingPairs>
  <TitlesOfParts>
    <vt:vector size="24" baseType="lpstr">
      <vt:lpstr>宋体</vt:lpstr>
      <vt:lpstr>Arial</vt:lpstr>
      <vt:lpstr>Calibri</vt:lpstr>
      <vt:lpstr>Calibri Light</vt:lpstr>
      <vt:lpstr>Times New Roman</vt:lpstr>
      <vt:lpstr>Office 主题</vt:lpstr>
      <vt:lpstr>Figure A.1 The BPC chromatograms of various micro-dissected tissues from Sample 1.</vt:lpstr>
      <vt:lpstr>Figure  A.2 The BPC chromatograms of various micro-dissected tissues from Sample 2.</vt:lpstr>
      <vt:lpstr>Figure  A.3 The BPC chromatograms of various micro-dissected tissues from Sample 3.</vt:lpstr>
      <vt:lpstr>Figure  A.4 The BPC chromatograms of various micro-dissected tissues from Sample 4.</vt:lpstr>
      <vt:lpstr>Figure  A.5 The BPC chromatograms of various micro-dissected tissues from Sample 5.</vt:lpstr>
      <vt:lpstr>Figure  A.6 The BPC chromatograms of various micro-dissected tissues from Sample 6.</vt:lpstr>
      <vt:lpstr>Figure  A.7 The BPC chromatograms of various micro-dissected tissues from Sample 7.</vt:lpstr>
      <vt:lpstr>Figure  A.8 The BPC chromatograms of various micro-dissected tissues from Sample 8.</vt:lpstr>
      <vt:lpstr>Figure  A.9 The BPC chromatograms of various micro-dissected tissues from Sample 9.</vt:lpstr>
      <vt:lpstr>Figure  A.10 The BPC chromatograms of various micro-dissected tissues from Sample 1.</vt:lpstr>
      <vt:lpstr>Figure  A.11 The BPC chromatograms of various micro-dissected tissues from Sample 2.</vt:lpstr>
      <vt:lpstr>Figure  A.12 The BPC chromatograms of various micro-dissected tissues from Sample 3.</vt:lpstr>
      <vt:lpstr>Figure  A.13 The BPC chromatograms of various micro-dissected tissues from Sample 4.</vt:lpstr>
      <vt:lpstr>Figure  A.14 The BPC chromatograms of various micro-dissected tissues from Sample 5.</vt:lpstr>
      <vt:lpstr>Figure  A.15 The BPC chromatograms of various micro-dissected tissues from Sample 6.</vt:lpstr>
      <vt:lpstr>Figure  A.16 The BPC chromatograms of various micro-dissected tissues from Sample 7.</vt:lpstr>
      <vt:lpstr>Figure  A.17 The BPC chromatograms of various micro-dissected tissues from Sample 8.</vt:lpstr>
      <vt:lpstr>Figure  A.18 The BPC chromatograms of various micro-dissected tissues from Sample 9.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njian xie</dc:creator>
  <cp:lastModifiedBy>wenjian xie</cp:lastModifiedBy>
  <cp:revision>9</cp:revision>
  <dcterms:created xsi:type="dcterms:W3CDTF">2016-01-20T12:31:36Z</dcterms:created>
  <dcterms:modified xsi:type="dcterms:W3CDTF">2016-04-11T11:37:40Z</dcterms:modified>
</cp:coreProperties>
</file>